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slides/slide38.xml" ContentType="application/vnd.openxmlformats-officedocument.presentationml.slide+xml"/>
  <Override PartName="/ppt/slides/slide39.xml" ContentType="application/vnd.openxmlformats-officedocument.presentationml.slide+xml"/>
  <Override PartName="/ppt/slides/slide40.xml" ContentType="application/vnd.openxmlformats-officedocument.presentationml.slide+xml"/>
  <Override PartName="/ppt/slides/slide41.xml" ContentType="application/vnd.openxmlformats-officedocument.presentationml.slide+xml"/>
  <Override PartName="/ppt/slides/slide42.xml" ContentType="application/vnd.openxmlformats-officedocument.presentationml.slide+xml"/>
  <Override PartName="/ppt/slides/slide43.xml" ContentType="application/vnd.openxmlformats-officedocument.presentationml.slide+xml"/>
  <Override PartName="/ppt/slides/slide44.xml" ContentType="application/vnd.openxmlformats-officedocument.presentationml.slide+xml"/>
  <Override PartName="/ppt/slides/slide45.xml" ContentType="application/vnd.openxmlformats-officedocument.presentationml.slide+xml"/>
  <Override PartName="/ppt/slides/slide46.xml" ContentType="application/vnd.openxmlformats-officedocument.presentationml.slide+xml"/>
  <Override PartName="/ppt/slides/slide47.xml" ContentType="application/vnd.openxmlformats-officedocument.presentationml.slide+xml"/>
  <Override PartName="/ppt/slides/slide48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55.xml" ContentType="application/vnd.openxmlformats-officedocument.presentationml.slide+xml"/>
  <Override PartName="/ppt/slides/slide56.xml" ContentType="application/vnd.openxmlformats-officedocument.presentationml.slide+xml"/>
  <Override PartName="/ppt/slides/slide57.xml" ContentType="application/vnd.openxmlformats-officedocument.presentationml.slide+xml"/>
  <Override PartName="/ppt/slides/slide58.xml" ContentType="application/vnd.openxmlformats-officedocument.presentationml.slide+xml"/>
  <Override PartName="/ppt/slides/slide59.xml" ContentType="application/vnd.openxmlformats-officedocument.presentationml.slide+xml"/>
  <Override PartName="/ppt/slides/slide60.xml" ContentType="application/vnd.openxmlformats-officedocument.presentationml.slide+xml"/>
  <Override PartName="/ppt/slides/slide61.xml" ContentType="application/vnd.openxmlformats-officedocument.presentationml.slide+xml"/>
  <Override PartName="/ppt/slides/slide62.xml" ContentType="application/vnd.openxmlformats-officedocument.presentationml.slide+xml"/>
  <Override PartName="/ppt/slides/slide63.xml" ContentType="application/vnd.openxmlformats-officedocument.presentationml.slide+xml"/>
  <Override PartName="/ppt/slides/slide64.xml" ContentType="application/vnd.openxmlformats-officedocument.presentationml.slide+xml"/>
  <Override PartName="/ppt/slides/slide65.xml" ContentType="application/vnd.openxmlformats-officedocument.presentationml.slide+xml"/>
  <Override PartName="/ppt/slides/slide6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2" r:id="rId2"/>
    <p:sldId id="328" r:id="rId3"/>
    <p:sldId id="294" r:id="rId4"/>
    <p:sldId id="295" r:id="rId5"/>
    <p:sldId id="296" r:id="rId6"/>
    <p:sldId id="297" r:id="rId7"/>
    <p:sldId id="298" r:id="rId8"/>
    <p:sldId id="299" r:id="rId9"/>
    <p:sldId id="300" r:id="rId10"/>
    <p:sldId id="301" r:id="rId11"/>
    <p:sldId id="302" r:id="rId12"/>
    <p:sldId id="303" r:id="rId13"/>
    <p:sldId id="304" r:id="rId14"/>
    <p:sldId id="305" r:id="rId15"/>
    <p:sldId id="306" r:id="rId16"/>
    <p:sldId id="307" r:id="rId17"/>
    <p:sldId id="308" r:id="rId18"/>
    <p:sldId id="309" r:id="rId19"/>
    <p:sldId id="310" r:id="rId20"/>
    <p:sldId id="311" r:id="rId21"/>
    <p:sldId id="312" r:id="rId22"/>
    <p:sldId id="313" r:id="rId23"/>
    <p:sldId id="314" r:id="rId24"/>
    <p:sldId id="315" r:id="rId25"/>
    <p:sldId id="316" r:id="rId26"/>
    <p:sldId id="317" r:id="rId27"/>
    <p:sldId id="318" r:id="rId28"/>
    <p:sldId id="319" r:id="rId29"/>
    <p:sldId id="320" r:id="rId30"/>
    <p:sldId id="321" r:id="rId31"/>
    <p:sldId id="323" r:id="rId32"/>
    <p:sldId id="330" r:id="rId33"/>
    <p:sldId id="258" r:id="rId34"/>
    <p:sldId id="259" r:id="rId35"/>
    <p:sldId id="260" r:id="rId36"/>
    <p:sldId id="261" r:id="rId37"/>
    <p:sldId id="262" r:id="rId38"/>
    <p:sldId id="263" r:id="rId39"/>
    <p:sldId id="264" r:id="rId40"/>
    <p:sldId id="265" r:id="rId41"/>
    <p:sldId id="266" r:id="rId42"/>
    <p:sldId id="267" r:id="rId43"/>
    <p:sldId id="268" r:id="rId44"/>
    <p:sldId id="269" r:id="rId45"/>
    <p:sldId id="270" r:id="rId46"/>
    <p:sldId id="271" r:id="rId47"/>
    <p:sldId id="272" r:id="rId48"/>
    <p:sldId id="273" r:id="rId49"/>
    <p:sldId id="274" r:id="rId50"/>
    <p:sldId id="275" r:id="rId51"/>
    <p:sldId id="276" r:id="rId52"/>
    <p:sldId id="277" r:id="rId53"/>
    <p:sldId id="278" r:id="rId54"/>
    <p:sldId id="291" r:id="rId55"/>
    <p:sldId id="279" r:id="rId56"/>
    <p:sldId id="280" r:id="rId57"/>
    <p:sldId id="281" r:id="rId58"/>
    <p:sldId id="282" r:id="rId59"/>
    <p:sldId id="283" r:id="rId60"/>
    <p:sldId id="284" r:id="rId61"/>
    <p:sldId id="285" r:id="rId62"/>
    <p:sldId id="286" r:id="rId63"/>
    <p:sldId id="287" r:id="rId64"/>
    <p:sldId id="288" r:id="rId65"/>
    <p:sldId id="289" r:id="rId66"/>
    <p:sldId id="290" r:id="rId67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2763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102" y="1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26" Type="http://schemas.openxmlformats.org/officeDocument/2006/relationships/slide" Target="slides/slide25.xml"/><Relationship Id="rId21" Type="http://schemas.openxmlformats.org/officeDocument/2006/relationships/slide" Target="slides/slide20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63" Type="http://schemas.openxmlformats.org/officeDocument/2006/relationships/slide" Target="slides/slide62.xml"/><Relationship Id="rId68" Type="http://schemas.openxmlformats.org/officeDocument/2006/relationships/presProps" Target="presProps.xml"/><Relationship Id="rId7" Type="http://schemas.openxmlformats.org/officeDocument/2006/relationships/slide" Target="slides/slide6.xml"/><Relationship Id="rId71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slide" Target="slides/slide52.xml"/><Relationship Id="rId58" Type="http://schemas.openxmlformats.org/officeDocument/2006/relationships/slide" Target="slides/slide57.xml"/><Relationship Id="rId66" Type="http://schemas.openxmlformats.org/officeDocument/2006/relationships/slide" Target="slides/slide65.xml"/><Relationship Id="rId5" Type="http://schemas.openxmlformats.org/officeDocument/2006/relationships/slide" Target="slides/slide4.xml"/><Relationship Id="rId61" Type="http://schemas.openxmlformats.org/officeDocument/2006/relationships/slide" Target="slides/slide60.xml"/><Relationship Id="rId19" Type="http://schemas.openxmlformats.org/officeDocument/2006/relationships/slide" Target="slides/slide1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slide" Target="slides/slide55.xml"/><Relationship Id="rId64" Type="http://schemas.openxmlformats.org/officeDocument/2006/relationships/slide" Target="slides/slide63.xml"/><Relationship Id="rId69" Type="http://schemas.openxmlformats.org/officeDocument/2006/relationships/viewProps" Target="viewProps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slide" Target="slides/slide58.xml"/><Relationship Id="rId67" Type="http://schemas.openxmlformats.org/officeDocument/2006/relationships/slide" Target="slides/slide66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62" Type="http://schemas.openxmlformats.org/officeDocument/2006/relationships/slide" Target="slides/slide61.xml"/><Relationship Id="rId7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slide" Target="slides/slide56.xml"/><Relationship Id="rId10" Type="http://schemas.openxmlformats.org/officeDocument/2006/relationships/slide" Target="slides/slide9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slide" Target="slides/slide59.xml"/><Relationship Id="rId65" Type="http://schemas.openxmlformats.org/officeDocument/2006/relationships/slide" Target="slides/slide64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9" Type="http://schemas.openxmlformats.org/officeDocument/2006/relationships/slide" Target="slides/slide38.xml"/><Relationship Id="rId34" Type="http://schemas.openxmlformats.org/officeDocument/2006/relationships/slide" Target="slides/slide33.xml"/><Relationship Id="rId50" Type="http://schemas.openxmlformats.org/officeDocument/2006/relationships/slide" Target="slides/slide49.xml"/><Relationship Id="rId55" Type="http://schemas.openxmlformats.org/officeDocument/2006/relationships/slide" Target="slides/slide54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48FDA-0CB2-41CC-B971-6E7ED5BA1197}" type="datetimeFigureOut">
              <a:rPr lang="ko-KR" altLang="en-US" smtClean="0"/>
              <a:t>2020-01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7C2E6-2397-4B4D-9FD3-512F45B75F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63416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48FDA-0CB2-41CC-B971-6E7ED5BA1197}" type="datetimeFigureOut">
              <a:rPr lang="ko-KR" altLang="en-US" smtClean="0"/>
              <a:t>2020-01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7C2E6-2397-4B4D-9FD3-512F45B75F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14567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48FDA-0CB2-41CC-B971-6E7ED5BA1197}" type="datetimeFigureOut">
              <a:rPr lang="ko-KR" altLang="en-US" smtClean="0"/>
              <a:t>2020-01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7C2E6-2397-4B4D-9FD3-512F45B75F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5128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48FDA-0CB2-41CC-B971-6E7ED5BA1197}" type="datetimeFigureOut">
              <a:rPr lang="ko-KR" altLang="en-US" smtClean="0"/>
              <a:t>2020-01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7C2E6-2397-4B4D-9FD3-512F45B75F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287700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48FDA-0CB2-41CC-B971-6E7ED5BA1197}" type="datetimeFigureOut">
              <a:rPr lang="ko-KR" altLang="en-US" smtClean="0"/>
              <a:t>2020-01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7C2E6-2397-4B4D-9FD3-512F45B75F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310764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48FDA-0CB2-41CC-B971-6E7ED5BA1197}" type="datetimeFigureOut">
              <a:rPr lang="ko-KR" altLang="en-US" smtClean="0"/>
              <a:t>2020-01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7C2E6-2397-4B4D-9FD3-512F45B75F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16924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48FDA-0CB2-41CC-B971-6E7ED5BA1197}" type="datetimeFigureOut">
              <a:rPr lang="ko-KR" altLang="en-US" smtClean="0"/>
              <a:t>2020-01-1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7C2E6-2397-4B4D-9FD3-512F45B75F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58586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48FDA-0CB2-41CC-B971-6E7ED5BA1197}" type="datetimeFigureOut">
              <a:rPr lang="ko-KR" altLang="en-US" smtClean="0"/>
              <a:t>2020-01-1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7C2E6-2397-4B4D-9FD3-512F45B75F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24475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48FDA-0CB2-41CC-B971-6E7ED5BA1197}" type="datetimeFigureOut">
              <a:rPr lang="ko-KR" altLang="en-US" smtClean="0"/>
              <a:t>2020-01-1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7C2E6-2397-4B4D-9FD3-512F45B75F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59920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48FDA-0CB2-41CC-B971-6E7ED5BA1197}" type="datetimeFigureOut">
              <a:rPr lang="ko-KR" altLang="en-US" smtClean="0"/>
              <a:t>2020-01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7C2E6-2397-4B4D-9FD3-512F45B75F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47935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448FDA-0CB2-41CC-B971-6E7ED5BA1197}" type="datetimeFigureOut">
              <a:rPr lang="ko-KR" altLang="en-US" smtClean="0"/>
              <a:t>2020-01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57C2E6-2397-4B4D-9FD3-512F45B75F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081829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448FDA-0CB2-41CC-B971-6E7ED5BA1197}" type="datetimeFigureOut">
              <a:rPr lang="ko-KR" altLang="en-US" smtClean="0"/>
              <a:t>2020-01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57C2E6-2397-4B4D-9FD3-512F45B75FB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75928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/Relationships>
</file>

<file path=ppt/slides/_rels/slide3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2.xml"/></Relationships>
</file>

<file path=ppt/slides/_rels/slide3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/Relationships>
</file>

<file path=ppt/slides/_rels/slide3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2.xml"/></Relationships>
</file>

<file path=ppt/slides/_rels/slide4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2.xml"/></Relationships>
</file>

<file path=ppt/slides/_rels/slide4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2.xml"/></Relationships>
</file>

<file path=ppt/slides/_rels/slide4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2.xml"/></Relationships>
</file>

<file path=ppt/slides/_rels/slide4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2.xml"/></Relationships>
</file>

<file path=ppt/slides/_rels/slide4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png"/><Relationship Id="rId1" Type="http://schemas.openxmlformats.org/officeDocument/2006/relationships/slideLayout" Target="../slideLayouts/slideLayout2.xml"/></Relationships>
</file>

<file path=ppt/slides/_rels/slide4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2.xml"/></Relationships>
</file>

<file path=ppt/slides/_rels/slide4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3.png"/><Relationship Id="rId1" Type="http://schemas.openxmlformats.org/officeDocument/2006/relationships/slideLayout" Target="../slideLayouts/slideLayout2.xml"/></Relationships>
</file>

<file path=ppt/slides/_rels/slide48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2.xml"/></Relationships>
</file>

<file path=ppt/slides/_rels/slide4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0.xml.rels><?xml version="1.0" encoding="UTF-8" standalone="yes"?>
<Relationships xmlns="http://schemas.openxmlformats.org/package/2006/relationships"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2.xml"/></Relationships>
</file>

<file path=ppt/slides/_rels/slide51.xml.rels><?xml version="1.0" encoding="UTF-8" standalone="yes"?>
<Relationships xmlns="http://schemas.openxmlformats.org/package/2006/relationships"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2.xml"/></Relationships>
</file>

<file path=ppt/slides/_rels/slide5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2.xml"/></Relationships>
</file>

<file path=ppt/slides/_rels/slide5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9.png"/><Relationship Id="rId1" Type="http://schemas.openxmlformats.org/officeDocument/2006/relationships/slideLayout" Target="../slideLayouts/slideLayout2.xml"/></Relationships>
</file>

<file path=ppt/slides/_rels/slide5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2.xml"/></Relationships>
</file>

<file path=ppt/slides/_rels/slide5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2.xml"/></Relationships>
</file>

<file path=ppt/slides/_rels/slide5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2.xml"/></Relationships>
</file>

<file path=ppt/slides/_rels/slide5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3.png"/><Relationship Id="rId1" Type="http://schemas.openxmlformats.org/officeDocument/2006/relationships/slideLayout" Target="../slideLayouts/slideLayout2.xml"/></Relationships>
</file>

<file path=ppt/slides/_rels/slide5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2.xml"/></Relationships>
</file>

<file path=ppt/slides/_rels/slide59.xml.rels><?xml version="1.0" encoding="UTF-8" standalone="yes"?>
<Relationships xmlns="http://schemas.openxmlformats.org/package/2006/relationships"><Relationship Id="rId2" Type="http://schemas.openxmlformats.org/officeDocument/2006/relationships/image" Target="../media/image5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0.xml.rels><?xml version="1.0" encoding="UTF-8" standalone="yes"?>
<Relationships xmlns="http://schemas.openxmlformats.org/package/2006/relationships"><Relationship Id="rId2" Type="http://schemas.openxmlformats.org/officeDocument/2006/relationships/image" Target="../media/image56.png"/><Relationship Id="rId1" Type="http://schemas.openxmlformats.org/officeDocument/2006/relationships/slideLayout" Target="../slideLayouts/slideLayout2.xml"/></Relationships>
</file>

<file path=ppt/slides/_rels/slide6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7.png"/><Relationship Id="rId1" Type="http://schemas.openxmlformats.org/officeDocument/2006/relationships/slideLayout" Target="../slideLayouts/slideLayout2.xml"/></Relationships>
</file>

<file path=ppt/slides/_rels/slide6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8.png"/><Relationship Id="rId1" Type="http://schemas.openxmlformats.org/officeDocument/2006/relationships/slideLayout" Target="../slideLayouts/slideLayout2.xml"/></Relationships>
</file>

<file path=ppt/slides/_rels/slide6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2.xml"/></Relationships>
</file>

<file path=ppt/slides/_rels/slide6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0.png"/><Relationship Id="rId1" Type="http://schemas.openxmlformats.org/officeDocument/2006/relationships/slideLayout" Target="../slideLayouts/slideLayout2.xml"/></Relationships>
</file>

<file path=ppt/slides/_rels/slide6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2.xml"/></Relationships>
</file>

<file path=ppt/slides/_rels/slide6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2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447089" y="1763297"/>
            <a:ext cx="9144000" cy="2387600"/>
          </a:xfrm>
        </p:spPr>
        <p:txBody>
          <a:bodyPr>
            <a:normAutofit/>
          </a:bodyPr>
          <a:lstStyle/>
          <a:p>
            <a:r>
              <a:rPr lang="en-GB" altLang="ko-KR" sz="4000" dirty="0">
                <a:solidFill>
                  <a:srgbClr val="000000"/>
                </a:solidFill>
                <a:latin typeface="Times New Roman" panose="02020603050405020304" pitchFamily="18" charset="0"/>
              </a:rPr>
              <a:t>Kaplan-Meier Curves Comparing </a:t>
            </a:r>
            <a:r>
              <a:rPr lang="en-GB" altLang="ko-KR" sz="40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Respiratory </a:t>
            </a:r>
            <a:r>
              <a:rPr lang="en-GB" altLang="ko-KR" sz="4000" dirty="0">
                <a:solidFill>
                  <a:srgbClr val="000000"/>
                </a:solidFill>
                <a:latin typeface="Times New Roman" panose="02020603050405020304" pitchFamily="18" charset="0"/>
              </a:rPr>
              <a:t>Mortalities in Entire Cohort According to Comorbidities and </a:t>
            </a:r>
            <a:r>
              <a:rPr lang="en-GB" altLang="ko-KR" sz="40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/>
            </a:r>
            <a:br>
              <a:rPr lang="en-GB" altLang="ko-KR" sz="40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</a:br>
            <a:r>
              <a:rPr lang="en-GB" altLang="ko-KR" sz="40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Clinical </a:t>
            </a:r>
            <a:r>
              <a:rPr lang="en-GB" altLang="ko-KR" sz="4000" dirty="0">
                <a:solidFill>
                  <a:srgbClr val="000000"/>
                </a:solidFill>
                <a:latin typeface="Times New Roman" panose="02020603050405020304" pitchFamily="18" charset="0"/>
              </a:rPr>
              <a:t>Variables</a:t>
            </a:r>
            <a:endParaRPr lang="ko-KR" altLang="en-US" sz="4000" b="1" dirty="0"/>
          </a:p>
        </p:txBody>
      </p:sp>
    </p:spTree>
    <p:extLst>
      <p:ext uri="{BB962C8B-B14F-4D97-AF65-F5344CB8AC3E}">
        <p14:creationId xmlns:p14="http://schemas.microsoft.com/office/powerpoint/2010/main" val="12258432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506505" y="997944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&lt;.0001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529697" y="1794617"/>
            <a:ext cx="18337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8. Use of LAMA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1460235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148531" y="1026379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949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119499" y="1905712"/>
            <a:ext cx="18362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9. Hypertension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6057329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772612" y="835336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132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775445" y="1880074"/>
            <a:ext cx="29971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0. Ischemic Heart Diseas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4318830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546980" y="966518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019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888763" y="2059537"/>
            <a:ext cx="25465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1. Cardiac arrhythmia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1945390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623180" y="852665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009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273323" y="2162086"/>
            <a:ext cx="1873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2. Heart failur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9217518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4016761" y="1034857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021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837489" y="2025353"/>
            <a:ext cx="30670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3. Cerebrovascular diseas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5209514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4046014" y="891002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073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572568" y="2162086"/>
            <a:ext cx="335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4. Peripheral vascular diseas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2445388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811047" y="749946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002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743342" y="2170632"/>
            <a:ext cx="13596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5. Asthma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7769286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763933" y="796895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002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230594" y="1743341"/>
            <a:ext cx="20408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6. Bronchiectasis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0079311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2895466" y="665503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024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529698" y="1273324"/>
            <a:ext cx="9476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7. DM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7308972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8200" y="501859"/>
            <a:ext cx="8160521" cy="839832"/>
          </a:xfrm>
        </p:spPr>
        <p:txBody>
          <a:bodyPr>
            <a:normAutofit/>
          </a:bodyPr>
          <a:lstStyle/>
          <a:p>
            <a:r>
              <a:rPr lang="en-GB" altLang="ko-KR" sz="24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st </a:t>
            </a:r>
            <a:r>
              <a:rPr lang="en-GB" altLang="ko-KR" sz="2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 Comorbidities and Clinical </a:t>
            </a:r>
            <a:r>
              <a:rPr lang="en-GB" altLang="ko-KR" sz="24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ariables</a:t>
            </a:r>
            <a:endParaRPr lang="ko-KR" alt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내용 개체 틀 3"/>
          <p:cNvSpPr>
            <a:spLocks noGrp="1"/>
          </p:cNvSpPr>
          <p:nvPr>
            <p:ph sz="half" idx="1"/>
          </p:nvPr>
        </p:nvSpPr>
        <p:spPr>
          <a:xfrm>
            <a:off x="990600" y="1743342"/>
            <a:ext cx="5181600" cy="4050706"/>
          </a:xfrm>
        </p:spPr>
        <p:txBody>
          <a:bodyPr>
            <a:normAutofit fontScale="70000" lnSpcReduction="20000"/>
          </a:bodyPr>
          <a:lstStyle/>
          <a:p>
            <a:pPr marL="514350" lvl="0" indent="-514350">
              <a:buFont typeface="+mj-lt"/>
              <a:buAutoNum type="arabicPeriod"/>
            </a:pP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x</a:t>
            </a:r>
            <a:endParaRPr lang="ko-KR" altLang="ko-KR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 group</a:t>
            </a:r>
            <a:endParaRPr lang="ko-KR" altLang="ko-KR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lth insurance type</a:t>
            </a:r>
            <a:endParaRPr lang="ko-KR" altLang="ko-KR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 of </a:t>
            </a:r>
            <a:r>
              <a:rPr lang="en-US" altLang="ko-KR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hylxanthines</a:t>
            </a:r>
            <a:endParaRPr lang="ko-KR" altLang="ko-KR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 of Systemic beta </a:t>
            </a:r>
            <a:r>
              <a:rPr lang="en-US" altLang="ko-KR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gnosit</a:t>
            </a:r>
            <a:endParaRPr lang="ko-KR" altLang="ko-KR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 of Inhaled corticosteroid (ICS)</a:t>
            </a:r>
            <a:endParaRPr lang="ko-KR" altLang="ko-KR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 of Long-acting beta-2 agonist (LABA)</a:t>
            </a:r>
            <a:endParaRPr lang="ko-KR" altLang="ko-KR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 of Long-acting muscarinic antagonist (LAMA)</a:t>
            </a:r>
            <a:endParaRPr lang="ko-KR" altLang="ko-KR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ypertension </a:t>
            </a:r>
            <a:endParaRPr lang="ko-KR" altLang="ko-KR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chemic heart disease </a:t>
            </a:r>
            <a:endParaRPr lang="ko-KR" altLang="ko-KR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rdiac arrhythmia </a:t>
            </a:r>
            <a:endParaRPr lang="ko-KR" altLang="ko-KR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rt failure </a:t>
            </a:r>
            <a:endParaRPr lang="ko-KR" altLang="ko-KR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rebrovascular disease </a:t>
            </a:r>
            <a:endParaRPr lang="ko-KR" altLang="ko-KR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ipheral vascular disease </a:t>
            </a:r>
            <a:endParaRPr lang="ko-KR" altLang="ko-KR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endParaRPr lang="ko-KR" altLang="en-US" dirty="0"/>
          </a:p>
        </p:txBody>
      </p:sp>
      <p:sp>
        <p:nvSpPr>
          <p:cNvPr id="6" name="내용 개체 틀 5"/>
          <p:cNvSpPr>
            <a:spLocks noGrp="1"/>
          </p:cNvSpPr>
          <p:nvPr>
            <p:ph sz="half" idx="2"/>
          </p:nvPr>
        </p:nvSpPr>
        <p:spPr>
          <a:xfrm>
            <a:off x="5650907" y="1743342"/>
            <a:ext cx="5253528" cy="4358354"/>
          </a:xfrm>
        </p:spPr>
        <p:txBody>
          <a:bodyPr>
            <a:normAutofit fontScale="70000" lnSpcReduction="20000"/>
          </a:bodyPr>
          <a:lstStyle/>
          <a:p>
            <a:pPr marL="0" lvl="0" indent="0">
              <a:buNone/>
            </a:pPr>
            <a:r>
              <a:rPr lang="en-US" altLang="ko-K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5. Asthma </a:t>
            </a:r>
            <a:endParaRPr lang="ko-KR" altLang="ko-KR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lvl="0" indent="0">
              <a:buNone/>
            </a:pPr>
            <a:r>
              <a:rPr lang="en-US" altLang="ko-K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6. Bronchiectasis </a:t>
            </a:r>
            <a:endParaRPr lang="ko-KR" altLang="ko-KR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lvl="0" indent="0">
              <a:buNone/>
            </a:pPr>
            <a:r>
              <a:rPr lang="en-US" altLang="ko-K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7. Diabetes 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llitus</a:t>
            </a:r>
            <a:endParaRPr lang="ko-KR" altLang="ko-KR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altLang="ko-K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8. Dyslipidemia</a:t>
            </a:r>
          </a:p>
          <a:p>
            <a:pPr marL="0" indent="0">
              <a:buNone/>
            </a:pPr>
            <a:r>
              <a:rPr lang="en-US" altLang="ko-K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9. Chronic 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dney </a:t>
            </a:r>
            <a:r>
              <a:rPr lang="en-US" altLang="ko-K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ease</a:t>
            </a:r>
          </a:p>
          <a:p>
            <a:pPr marL="0" indent="0">
              <a:buNone/>
            </a:pPr>
            <a:r>
              <a:rPr lang="en-US" altLang="ko-K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. Osteoporosis </a:t>
            </a:r>
            <a:endParaRPr lang="en-US" altLang="ko-KR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altLang="ko-K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1. Gastroesophageal 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flux disease</a:t>
            </a:r>
          </a:p>
          <a:p>
            <a:pPr marL="0" indent="0">
              <a:buNone/>
            </a:pPr>
            <a:r>
              <a:rPr lang="en-US" altLang="ko-K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2. Chronic 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er disease such as liver cirrhosis or </a:t>
            </a:r>
            <a:r>
              <a:rPr lang="en-US" altLang="ko-K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atty liver 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ease </a:t>
            </a:r>
          </a:p>
          <a:p>
            <a:pPr marL="0" indent="0">
              <a:buNone/>
            </a:pPr>
            <a:r>
              <a:rPr lang="en-US" altLang="ko-K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3. Malignancy </a:t>
            </a:r>
            <a:endParaRPr lang="en-US" altLang="ko-KR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altLang="ko-K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4. Lung 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cer </a:t>
            </a:r>
          </a:p>
          <a:p>
            <a:pPr marL="0" indent="0">
              <a:buNone/>
            </a:pPr>
            <a:r>
              <a:rPr lang="en-US" altLang="ko-K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. Stomach 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cer </a:t>
            </a:r>
          </a:p>
          <a:p>
            <a:pPr marL="0" indent="0">
              <a:buNone/>
            </a:pPr>
            <a:r>
              <a:rPr lang="en-US" altLang="ko-K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6. Colorectal 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cer</a:t>
            </a:r>
          </a:p>
          <a:p>
            <a:pPr marL="0" indent="0">
              <a:buNone/>
            </a:pPr>
            <a:r>
              <a:rPr lang="en-US" altLang="ko-K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7. Liver 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cer</a:t>
            </a:r>
          </a:p>
          <a:p>
            <a:pPr marL="0" indent="0">
              <a:buNone/>
            </a:pPr>
            <a:r>
              <a:rPr lang="en-US" altLang="ko-KR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8. Thyroid </a:t>
            </a:r>
            <a:r>
              <a:rPr lang="en-US" altLang="ko-KR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cer</a:t>
            </a:r>
          </a:p>
          <a:p>
            <a:pPr marL="0" indent="0">
              <a:buNone/>
            </a:pP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8899192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436255" y="855453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028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1256232" y="1666430"/>
            <a:ext cx="18982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8. Dyslipidemia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2511094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251452" y="842161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626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828800" y="1529696"/>
            <a:ext cx="1018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9. CKD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4044738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299523" y="871812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429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311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1486969" y="1931350"/>
            <a:ext cx="1934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0. Osteoporosis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5859583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493939" y="805039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&lt;.0001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572426" y="2221906"/>
            <a:ext cx="1157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1. GERD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008112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601429" y="819461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429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011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837488" y="1931350"/>
            <a:ext cx="27174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2. Chronic liver diseas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0607972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533330" y="819595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090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1495514" y="2119357"/>
            <a:ext cx="17636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3. Malignancy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203628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499413" y="728128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019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580972" y="1743342"/>
            <a:ext cx="18453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4. Lung cancer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8816909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그룹 2"/>
          <p:cNvGrpSpPr/>
          <p:nvPr/>
        </p:nvGrpSpPr>
        <p:grpSpPr>
          <a:xfrm>
            <a:off x="3630271" y="799165"/>
            <a:ext cx="7200000" cy="5400000"/>
            <a:chOff x="3630271" y="799165"/>
            <a:chExt cx="7200000" cy="5400000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630271" y="799165"/>
              <a:ext cx="7200000" cy="5400000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5768751" y="2885757"/>
              <a:ext cx="539417" cy="2178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626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068224" y="1777526"/>
            <a:ext cx="2265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5. Stomach Cancer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5858036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524784" y="785145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476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016951" y="1888621"/>
            <a:ext cx="24111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6. Colorectal Cancer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2816250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291110" y="696748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957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" name="TextBox 6"/>
          <p:cNvSpPr txBox="1"/>
          <p:nvPr/>
        </p:nvSpPr>
        <p:spPr>
          <a:xfrm>
            <a:off x="1128044" y="2110812"/>
            <a:ext cx="18118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7. Liver cancer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9559762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2708957" y="889106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&lt;.0001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1290414" y="982768"/>
            <a:ext cx="886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342900" indent="-342900">
              <a:lnSpc>
                <a:spcPct val="100000"/>
              </a:lnSpc>
              <a:buFont typeface="+mj-lt"/>
              <a:buAutoNum type="arabicPeriod"/>
            </a:pPr>
            <a:r>
              <a:rPr lang="en-US" altLang="ko-KR" dirty="0"/>
              <a:t>Sex</a:t>
            </a:r>
          </a:p>
        </p:txBody>
      </p:sp>
    </p:spTree>
    <p:extLst>
      <p:ext uri="{BB962C8B-B14F-4D97-AF65-F5344CB8AC3E}">
        <p14:creationId xmlns:p14="http://schemas.microsoft.com/office/powerpoint/2010/main" val="23429749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50288" y="1222181"/>
            <a:ext cx="7200000" cy="48060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187865" y="2486826"/>
            <a:ext cx="2111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8. Thyroid cancer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5426220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58183" y="2182042"/>
            <a:ext cx="9144000" cy="2387600"/>
          </a:xfrm>
        </p:spPr>
        <p:txBody>
          <a:bodyPr>
            <a:normAutofit/>
          </a:bodyPr>
          <a:lstStyle/>
          <a:p>
            <a:r>
              <a:rPr lang="en-GB" altLang="ko-KR" sz="4000" dirty="0">
                <a:solidFill>
                  <a:srgbClr val="000000"/>
                </a:solidFill>
                <a:latin typeface="Times New Roman" panose="02020603050405020304" pitchFamily="18" charset="0"/>
              </a:rPr>
              <a:t>Kaplan-Meier Curves Comparing Respiratory Mortalities in Health-screening Cohort </a:t>
            </a:r>
            <a:r>
              <a:rPr lang="en-GB" altLang="ko-KR" sz="40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According </a:t>
            </a:r>
            <a:r>
              <a:rPr lang="en-GB" altLang="ko-KR" sz="4000" dirty="0">
                <a:solidFill>
                  <a:srgbClr val="000000"/>
                </a:solidFill>
                <a:latin typeface="Times New Roman" panose="02020603050405020304" pitchFamily="18" charset="0"/>
              </a:rPr>
              <a:t>to Comorbidities and </a:t>
            </a:r>
            <a:br>
              <a:rPr lang="en-GB" altLang="ko-KR" sz="4000" dirty="0">
                <a:solidFill>
                  <a:srgbClr val="000000"/>
                </a:solidFill>
                <a:latin typeface="Times New Roman" panose="02020603050405020304" pitchFamily="18" charset="0"/>
              </a:rPr>
            </a:br>
            <a:r>
              <a:rPr lang="en-GB" altLang="ko-KR" sz="4000" dirty="0">
                <a:solidFill>
                  <a:srgbClr val="000000"/>
                </a:solidFill>
                <a:latin typeface="Times New Roman" panose="02020603050405020304" pitchFamily="18" charset="0"/>
              </a:rPr>
              <a:t>Clinical Variables</a:t>
            </a:r>
            <a:endParaRPr lang="ko-KR" altLang="en-US" sz="4000" b="1" dirty="0"/>
          </a:p>
        </p:txBody>
      </p:sp>
    </p:spTree>
    <p:extLst>
      <p:ext uri="{BB962C8B-B14F-4D97-AF65-F5344CB8AC3E}">
        <p14:creationId xmlns:p14="http://schemas.microsoft.com/office/powerpoint/2010/main" val="42225377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8200" y="365126"/>
            <a:ext cx="6750465" cy="839832"/>
          </a:xfrm>
        </p:spPr>
        <p:txBody>
          <a:bodyPr>
            <a:normAutofit/>
          </a:bodyPr>
          <a:lstStyle/>
          <a:p>
            <a:r>
              <a:rPr lang="en-GB" altLang="ko-KR" sz="24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st of Comorbidities and Clinical Variables</a:t>
            </a:r>
            <a:endParaRPr lang="ko-KR" altLang="en-US" sz="2400" dirty="0"/>
          </a:p>
        </p:txBody>
      </p:sp>
      <p:sp>
        <p:nvSpPr>
          <p:cNvPr id="4" name="내용 개체 틀 3"/>
          <p:cNvSpPr>
            <a:spLocks noGrp="1"/>
          </p:cNvSpPr>
          <p:nvPr>
            <p:ph sz="half" idx="1"/>
          </p:nvPr>
        </p:nvSpPr>
        <p:spPr>
          <a:xfrm>
            <a:off x="914400" y="1391318"/>
            <a:ext cx="5181600" cy="4802736"/>
          </a:xfrm>
        </p:spPr>
        <p:txBody>
          <a:bodyPr>
            <a:normAutofit fontScale="40000" lnSpcReduction="20000"/>
          </a:bodyPr>
          <a:lstStyle/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x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ge group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lth insurance type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 of </a:t>
            </a:r>
            <a:r>
              <a:rPr lang="en-US" altLang="ko-KR" sz="3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hylxanthines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 of Systemic beta </a:t>
            </a:r>
            <a:r>
              <a:rPr lang="en-US" altLang="ko-KR" sz="3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gnosit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 of Inhaled corticosteroid (ICS)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 of Long-acting beta-2 agonist (LABA)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se of Long-acting muscarinic antagonist (LAMA)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ypertension 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chemic heart disease 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rdiac arrhythmia 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art failure 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rebrovascular disease 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ripheral vascular disease 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thma 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ronchiectasis 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514350" lvl="0" indent="-514350">
              <a:buFont typeface="+mj-lt"/>
              <a:buAutoNum type="arabicPeriod"/>
            </a:pP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abetes mellitus</a:t>
            </a:r>
            <a:endParaRPr lang="ko-KR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endParaRPr lang="ko-KR" altLang="en-US" dirty="0"/>
          </a:p>
        </p:txBody>
      </p:sp>
      <p:sp>
        <p:nvSpPr>
          <p:cNvPr id="6" name="내용 개체 틀 5"/>
          <p:cNvSpPr>
            <a:spLocks noGrp="1"/>
          </p:cNvSpPr>
          <p:nvPr>
            <p:ph sz="half" idx="2"/>
          </p:nvPr>
        </p:nvSpPr>
        <p:spPr>
          <a:xfrm>
            <a:off x="6197838" y="1391318"/>
            <a:ext cx="5181600" cy="4972006"/>
          </a:xfrm>
        </p:spPr>
        <p:txBody>
          <a:bodyPr>
            <a:normAutofit fontScale="40000" lnSpcReduction="20000"/>
          </a:bodyPr>
          <a:lstStyle/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8. Dyslipidemia</a:t>
            </a:r>
          </a:p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9. Chronic </a:t>
            </a: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dney </a:t>
            </a: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ease</a:t>
            </a:r>
          </a:p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. Osteoporosis </a:t>
            </a:r>
            <a:endParaRPr lang="en-US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1. Gastroesophageal </a:t>
            </a: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flux disease</a:t>
            </a:r>
          </a:p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2. Chronic </a:t>
            </a: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er disease such as liver cirrhosis or fatty liver disease </a:t>
            </a:r>
          </a:p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3. Malignancy </a:t>
            </a:r>
            <a:endParaRPr lang="en-US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4. Lung </a:t>
            </a: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cer </a:t>
            </a:r>
          </a:p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. Stomach </a:t>
            </a: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cer </a:t>
            </a:r>
          </a:p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6. Colorectal </a:t>
            </a: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cer</a:t>
            </a:r>
          </a:p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7. Liver </a:t>
            </a: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cer</a:t>
            </a:r>
          </a:p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8. Thyroid </a:t>
            </a: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cer</a:t>
            </a:r>
          </a:p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9. BMI</a:t>
            </a:r>
            <a:endParaRPr lang="en-US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0. Hemoglobin</a:t>
            </a:r>
            <a:endParaRPr lang="en-US" altLang="ko-KR" sz="3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1. Fasting </a:t>
            </a: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ood glucose</a:t>
            </a:r>
          </a:p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2. Total </a:t>
            </a: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olesterol</a:t>
            </a:r>
          </a:p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3. Serum </a:t>
            </a: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eatinine</a:t>
            </a:r>
          </a:p>
          <a:p>
            <a:pPr marL="0" indent="0">
              <a:buNone/>
            </a:pPr>
            <a:r>
              <a:rPr lang="en-US" altLang="ko-KR" sz="35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4. Smoking </a:t>
            </a:r>
            <a:r>
              <a:rPr lang="en-US" altLang="ko-KR" sz="3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us</a:t>
            </a:r>
          </a:p>
          <a:p>
            <a:pPr marL="0" indent="0">
              <a:buNone/>
            </a:pP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4822625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342974" y="890826"/>
            <a:ext cx="7200000" cy="5400000"/>
            <a:chOff x="390525" y="-500063"/>
            <a:chExt cx="11410950" cy="78581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90525" y="-500063"/>
              <a:ext cx="11410950" cy="78581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9060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&lt;.0001 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880075" y="1657884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. Sex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8550862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434048" y="773138"/>
            <a:ext cx="7200000" cy="5400000"/>
            <a:chOff x="390525" y="-500063"/>
            <a:chExt cx="11410950" cy="78581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90525" y="-500063"/>
              <a:ext cx="11410950" cy="78581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&lt;.0001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1264778" y="1674976"/>
            <a:ext cx="1567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. Age group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7977011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460662" y="665583"/>
            <a:ext cx="7200000" cy="5400000"/>
            <a:chOff x="390525" y="-500063"/>
            <a:chExt cx="11410950" cy="78581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90525" y="-500063"/>
              <a:ext cx="11410950" cy="78581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95571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4651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598206" y="1991170"/>
            <a:ext cx="27318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3. Health insurance typ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8345266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277173" y="883746"/>
            <a:ext cx="7200000" cy="5400000"/>
            <a:chOff x="390525" y="-500063"/>
            <a:chExt cx="11410950" cy="78581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90525" y="-500063"/>
              <a:ext cx="11410950" cy="78581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249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495657" y="1880075"/>
            <a:ext cx="29036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4. Use of </a:t>
            </a:r>
            <a:r>
              <a:rPr lang="en-US" altLang="ko-KR" dirty="0" err="1" smtClean="0"/>
              <a:t>Methylxanthines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6417215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875150" y="857619"/>
            <a:ext cx="7200000" cy="5400000"/>
            <a:chOff x="390525" y="-500063"/>
            <a:chExt cx="11410950" cy="78581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90525" y="-500063"/>
              <a:ext cx="11410950" cy="78581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090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401122" y="1760434"/>
            <a:ext cx="34740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5. Use of systemic beta agonist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7369069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464691" y="806479"/>
            <a:ext cx="7200000" cy="5400000"/>
            <a:chOff x="390525" y="-500063"/>
            <a:chExt cx="11410950" cy="78581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90525" y="-500063"/>
              <a:ext cx="11410950" cy="78581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420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1333144" y="2384277"/>
            <a:ext cx="15331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6. Use of ICS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8863567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522436" y="954553"/>
            <a:ext cx="7200000" cy="5400000"/>
            <a:chOff x="390525" y="-500063"/>
            <a:chExt cx="11410950" cy="78581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90525" y="-500063"/>
              <a:ext cx="11410950" cy="78581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805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247686" y="2136449"/>
            <a:ext cx="1756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7. Use of LABA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4053671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2906702" y="544334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&lt;.0001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직사각형 1"/>
          <p:cNvSpPr/>
          <p:nvPr/>
        </p:nvSpPr>
        <p:spPr>
          <a:xfrm>
            <a:off x="1233806" y="1039519"/>
            <a:ext cx="156799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lnSpc>
                <a:spcPct val="100000"/>
              </a:lnSpc>
            </a:pPr>
            <a:r>
              <a:rPr lang="en-US" altLang="ko-KR" dirty="0" smtClean="0"/>
              <a:t>2. Age </a:t>
            </a:r>
            <a:r>
              <a:rPr lang="en-US" altLang="ko-KR" dirty="0"/>
              <a:t>group</a:t>
            </a:r>
          </a:p>
        </p:txBody>
      </p:sp>
    </p:spTree>
    <p:extLst>
      <p:ext uri="{BB962C8B-B14F-4D97-AF65-F5344CB8AC3E}">
        <p14:creationId xmlns:p14="http://schemas.microsoft.com/office/powerpoint/2010/main" val="39544585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697500" y="896961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181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401510" y="1897166"/>
            <a:ext cx="18337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8. Use of LAMA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542751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659778" y="880114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507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580972" y="1862983"/>
            <a:ext cx="18362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9. Hypertension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9136363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734693" y="977046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016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796837" y="2050991"/>
            <a:ext cx="29378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0. Ischemic heart diseas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5691976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574808" y="863876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018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1230595" y="2179178"/>
            <a:ext cx="17274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1. Arrhythmia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7431006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547705" y="735690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032</a:t>
              </a: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324598" y="1982625"/>
            <a:ext cx="1873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2. Heart failur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2200709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517551" y="559279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&lt;.0001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487110" y="2102266"/>
            <a:ext cx="29196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3. Cardiovascular diseas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8901396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4012719" y="823712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060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529838" y="1931349"/>
            <a:ext cx="335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4. Peripheral vascular diseas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371140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543677" y="871812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287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1324598" y="2119358"/>
            <a:ext cx="13596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5. Asthma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8205967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425989" y="639121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283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931491" y="2068082"/>
            <a:ext cx="20408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6. Bronchiectasis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1620416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428553" y="911245"/>
            <a:ext cx="7200000" cy="5400000"/>
            <a:chOff x="890452" y="424134"/>
            <a:chExt cx="7200000" cy="5400000"/>
          </a:xfrm>
        </p:grpSpPr>
        <p:pic>
          <p:nvPicPr>
            <p:cNvPr id="5" name="그림 4"/>
            <p:cNvPicPr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90452" y="424134"/>
              <a:ext cx="7200000" cy="5400000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546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649339" y="2238998"/>
            <a:ext cx="9476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7. DM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9550875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455323" y="628921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&lt;.0001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658025" y="1239140"/>
            <a:ext cx="27678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3. Health Insurance Typ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9876913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493380" y="924674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922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324598" y="2256090"/>
            <a:ext cx="18982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8. Dyslipidemia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689065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543677" y="887438"/>
            <a:ext cx="7200000" cy="5400000"/>
            <a:chOff x="381000" y="-385763"/>
            <a:chExt cx="11430000" cy="7629525"/>
          </a:xfrm>
        </p:grpSpPr>
        <p:pic>
          <p:nvPicPr>
            <p:cNvPr id="6" name="그림 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1808703" y="2562330"/>
              <a:ext cx="95571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5349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1632247" y="2589376"/>
            <a:ext cx="1018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19. CKD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9081938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867807" y="940789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432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341690" y="1920926"/>
            <a:ext cx="19347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0. Osteoporosis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6048534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294749" y="876451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95571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0085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367327" y="2444097"/>
            <a:ext cx="11576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1. GERD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8046097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898570" y="643761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225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670111" y="2110813"/>
            <a:ext cx="27174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2. Chronic liver diseas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4349530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727167" y="773901"/>
            <a:ext cx="7200000" cy="5400000"/>
            <a:chOff x="381000" y="-385763"/>
            <a:chExt cx="11430000" cy="7629525"/>
          </a:xfrm>
        </p:grpSpPr>
        <p:pic>
          <p:nvPicPr>
            <p:cNvPr id="6" name="그림 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745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1119499" y="1905713"/>
            <a:ext cx="17636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3. Malignancy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7612720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344071" y="687955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364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" name="TextBox 6"/>
          <p:cNvSpPr txBox="1"/>
          <p:nvPr/>
        </p:nvSpPr>
        <p:spPr>
          <a:xfrm>
            <a:off x="1085317" y="2127903"/>
            <a:ext cx="18453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4. Lung cancer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0023844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40150" y="1003173"/>
            <a:ext cx="7200000" cy="48060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700755" y="1598064"/>
            <a:ext cx="22650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5. Stomach Cancer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6917556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그룹 2"/>
          <p:cNvGrpSpPr/>
          <p:nvPr/>
        </p:nvGrpSpPr>
        <p:grpSpPr>
          <a:xfrm>
            <a:off x="3374328" y="524120"/>
            <a:ext cx="8089888" cy="5400000"/>
            <a:chOff x="3220504" y="848860"/>
            <a:chExt cx="8089888" cy="5400000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220504" y="848860"/>
              <a:ext cx="8089888" cy="5400000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6281809" y="3241083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202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" name="TextBox 3"/>
          <p:cNvSpPr txBox="1"/>
          <p:nvPr/>
        </p:nvSpPr>
        <p:spPr>
          <a:xfrm>
            <a:off x="717847" y="1768981"/>
            <a:ext cx="24111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6. Colorectal Cancer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7213187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72192" y="775977"/>
            <a:ext cx="8089888" cy="54000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837487" y="1888620"/>
            <a:ext cx="18118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7. Liver cancer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3402105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158487" y="810648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181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613880" y="1529698"/>
            <a:ext cx="28042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4 .Use of </a:t>
            </a:r>
            <a:r>
              <a:rPr lang="en-US" altLang="ko-KR" dirty="0" err="1"/>
              <a:t>M</a:t>
            </a:r>
            <a:r>
              <a:rPr lang="en-US" altLang="ko-KR" dirty="0" err="1" smtClean="0"/>
              <a:t>ethylxanthin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2092194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06324" y="763280"/>
            <a:ext cx="7265687" cy="54000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008403" y="1862983"/>
            <a:ext cx="2111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8. Thyroid cancer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0769941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3614870" y="787087"/>
            <a:ext cx="6983677" cy="5400000"/>
            <a:chOff x="1226790" y="693083"/>
            <a:chExt cx="8089888" cy="5400000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26790" y="693083"/>
              <a:ext cx="8089888" cy="5400000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17643" y="2601519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&lt;.0001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1580972" y="1555335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29. BMI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1670003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414024" y="966426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94237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1121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1110954" y="1683521"/>
            <a:ext cx="18630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30. Hemoglobin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9055784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722526" y="761327"/>
            <a:ext cx="7200000" cy="5400000"/>
            <a:chOff x="381000" y="-385763"/>
            <a:chExt cx="11430000" cy="7629525"/>
          </a:xfrm>
        </p:grpSpPr>
        <p:pic>
          <p:nvPicPr>
            <p:cNvPr id="8" name="그림 7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175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" name="TextBox 4"/>
          <p:cNvSpPr txBox="1"/>
          <p:nvPr/>
        </p:nvSpPr>
        <p:spPr>
          <a:xfrm>
            <a:off x="846033" y="1700613"/>
            <a:ext cx="28764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31. Fasting blood glucos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7980797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565774" y="834698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015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034040" y="1632247"/>
            <a:ext cx="22777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mtClean="0"/>
              <a:t>32. </a:t>
            </a:r>
            <a:r>
              <a:rPr lang="en-US" altLang="ko-KR" dirty="0" smtClean="0"/>
              <a:t>Total cholesterol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0525774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245062" y="736666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633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957129" y="1640793"/>
            <a:ext cx="23694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33. Serum Creatinine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2329887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547217" y="809062"/>
            <a:ext cx="7200000" cy="5400000"/>
            <a:chOff x="381000" y="-385763"/>
            <a:chExt cx="11430000" cy="7629525"/>
          </a:xfrm>
        </p:grpSpPr>
        <p:pic>
          <p:nvPicPr>
            <p:cNvPr id="6" name="그림 5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075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" name="TextBox 2"/>
          <p:cNvSpPr txBox="1"/>
          <p:nvPr/>
        </p:nvSpPr>
        <p:spPr>
          <a:xfrm>
            <a:off x="1230594" y="1777525"/>
            <a:ext cx="21771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34. Smoking status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9825172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4046595" y="637467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357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572567" y="1486968"/>
            <a:ext cx="34740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5. Use of systemic beta agonist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5832071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776459" y="879221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022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692067" y="1674976"/>
            <a:ext cx="15331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6. Use of ICS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6109078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3334095" y="941091"/>
            <a:ext cx="7200000" cy="5400000"/>
            <a:chOff x="381000" y="-385763"/>
            <a:chExt cx="11430000" cy="7629525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1000" y="-385763"/>
              <a:ext cx="11430000" cy="762952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808703" y="2562330"/>
              <a:ext cx="85632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035</a:t>
              </a:r>
              <a:endParaRPr lang="ko-KR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1392965" y="1384418"/>
            <a:ext cx="1756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7. Use of LABA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2995644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6</TotalTime>
  <Words>599</Words>
  <Application>Microsoft Office PowerPoint</Application>
  <PresentationFormat>와이드스크린</PresentationFormat>
  <Paragraphs>186</Paragraphs>
  <Slides>66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66</vt:i4>
      </vt:variant>
    </vt:vector>
  </HeadingPairs>
  <TitlesOfParts>
    <vt:vector size="70" baseType="lpstr">
      <vt:lpstr>맑은 고딕</vt:lpstr>
      <vt:lpstr>Arial</vt:lpstr>
      <vt:lpstr>Times New Roman</vt:lpstr>
      <vt:lpstr>Office 테마</vt:lpstr>
      <vt:lpstr>Kaplan-Meier Curves Comparing Respiratory Mortalities in Entire Cohort According to Comorbidities and  Clinical Variables</vt:lpstr>
      <vt:lpstr>List of Comorbidities and Clinical Variables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Kaplan-Meier Curves Comparing Respiratory Mortalities in Health-screening Cohort According to Comorbidities and  Clinical Variables</vt:lpstr>
      <vt:lpstr>List of Comorbidities and Clinical Variables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E cohort</dc:title>
  <dc:creator>ROOM079_kimyejee33</dc:creator>
  <cp:lastModifiedBy>Windows 사용자</cp:lastModifiedBy>
  <cp:revision>31</cp:revision>
  <dcterms:created xsi:type="dcterms:W3CDTF">2019-07-10T09:34:09Z</dcterms:created>
  <dcterms:modified xsi:type="dcterms:W3CDTF">2020-01-19T05:37:03Z</dcterms:modified>
</cp:coreProperties>
</file>